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2130" y="-29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牧野 友幸" userId="3418e839-faa9-476d-b509-1fc4b11e6ea9" providerId="ADAL" clId="{0D8C08F9-12F7-469E-9D6D-956F12240F7D}"/>
    <pc:docChg chg="modSld">
      <pc:chgData name="牧野 友幸" userId="3418e839-faa9-476d-b509-1fc4b11e6ea9" providerId="ADAL" clId="{0D8C08F9-12F7-469E-9D6D-956F12240F7D}" dt="2025-08-06T01:29:38.059" v="12" actId="552"/>
      <pc:docMkLst>
        <pc:docMk/>
      </pc:docMkLst>
      <pc:sldChg chg="modSp mod">
        <pc:chgData name="牧野 友幸" userId="3418e839-faa9-476d-b509-1fc4b11e6ea9" providerId="ADAL" clId="{0D8C08F9-12F7-469E-9D6D-956F12240F7D}" dt="2025-08-06T01:29:38.059" v="12" actId="552"/>
        <pc:sldMkLst>
          <pc:docMk/>
          <pc:sldMk cId="2226767344" sldId="273"/>
        </pc:sldMkLst>
        <pc:spChg chg="mod">
          <ac:chgData name="牧野 友幸" userId="3418e839-faa9-476d-b509-1fc4b11e6ea9" providerId="ADAL" clId="{0D8C08F9-12F7-469E-9D6D-956F12240F7D}" dt="2025-08-06T01:29:01.542" v="9" actId="552"/>
          <ac:spMkLst>
            <pc:docMk/>
            <pc:sldMk cId="2226767344" sldId="273"/>
            <ac:spMk id="4" creationId="{9B6AC1B4-33BB-2E36-7247-8485AF499DE6}"/>
          </ac:spMkLst>
        </pc:spChg>
        <pc:spChg chg="mod">
          <ac:chgData name="牧野 友幸" userId="3418e839-faa9-476d-b509-1fc4b11e6ea9" providerId="ADAL" clId="{0D8C08F9-12F7-469E-9D6D-956F12240F7D}" dt="2025-08-06T01:29:29.460" v="11" actId="552"/>
          <ac:spMkLst>
            <pc:docMk/>
            <pc:sldMk cId="2226767344" sldId="273"/>
            <ac:spMk id="6" creationId="{54799714-45D6-6AF1-F4CD-356172619C31}"/>
          </ac:spMkLst>
        </pc:spChg>
        <pc:spChg chg="mod">
          <ac:chgData name="牧野 友幸" userId="3418e839-faa9-476d-b509-1fc4b11e6ea9" providerId="ADAL" clId="{0D8C08F9-12F7-469E-9D6D-956F12240F7D}" dt="2025-08-06T01:29:38.059" v="12" actId="552"/>
          <ac:spMkLst>
            <pc:docMk/>
            <pc:sldMk cId="2226767344" sldId="273"/>
            <ac:spMk id="9" creationId="{6E9AA248-65E3-6DC4-089A-8B310A4C72A1}"/>
          </ac:spMkLst>
        </pc:spChg>
        <pc:spChg chg="mod">
          <ac:chgData name="牧野 友幸" userId="3418e839-faa9-476d-b509-1fc4b11e6ea9" providerId="ADAL" clId="{0D8C08F9-12F7-469E-9D6D-956F12240F7D}" dt="2025-08-06T01:29:29.460" v="11" actId="552"/>
          <ac:spMkLst>
            <pc:docMk/>
            <pc:sldMk cId="2226767344" sldId="273"/>
            <ac:spMk id="26" creationId="{E6A23C48-EDB0-DE03-9C8B-9F5966B912E6}"/>
          </ac:spMkLst>
        </pc:spChg>
        <pc:spChg chg="mod">
          <ac:chgData name="牧野 友幸" userId="3418e839-faa9-476d-b509-1fc4b11e6ea9" providerId="ADAL" clId="{0D8C08F9-12F7-469E-9D6D-956F12240F7D}" dt="2025-08-06T01:29:29.460" v="11" actId="552"/>
          <ac:spMkLst>
            <pc:docMk/>
            <pc:sldMk cId="2226767344" sldId="273"/>
            <ac:spMk id="27" creationId="{34EA92E8-3036-4343-C2CA-3222CB112754}"/>
          </ac:spMkLst>
        </pc:spChg>
        <pc:spChg chg="mod">
          <ac:chgData name="牧野 友幸" userId="3418e839-faa9-476d-b509-1fc4b11e6ea9" providerId="ADAL" clId="{0D8C08F9-12F7-469E-9D6D-956F12240F7D}" dt="2025-08-06T01:29:29.460" v="11" actId="552"/>
          <ac:spMkLst>
            <pc:docMk/>
            <pc:sldMk cId="2226767344" sldId="273"/>
            <ac:spMk id="28" creationId="{67062A59-303E-EEF4-C02A-1539C4384E72}"/>
          </ac:spMkLst>
        </pc:spChg>
        <pc:spChg chg="mod">
          <ac:chgData name="牧野 友幸" userId="3418e839-faa9-476d-b509-1fc4b11e6ea9" providerId="ADAL" clId="{0D8C08F9-12F7-469E-9D6D-956F12240F7D}" dt="2025-08-06T01:29:38.059" v="12" actId="552"/>
          <ac:spMkLst>
            <pc:docMk/>
            <pc:sldMk cId="2226767344" sldId="273"/>
            <ac:spMk id="29" creationId="{6078217E-5176-2D88-82DA-9FE03F235583}"/>
          </ac:spMkLst>
        </pc:spChg>
        <pc:spChg chg="mod">
          <ac:chgData name="牧野 友幸" userId="3418e839-faa9-476d-b509-1fc4b11e6ea9" providerId="ADAL" clId="{0D8C08F9-12F7-469E-9D6D-956F12240F7D}" dt="2025-08-06T01:29:38.059" v="12" actId="552"/>
          <ac:spMkLst>
            <pc:docMk/>
            <pc:sldMk cId="2226767344" sldId="273"/>
            <ac:spMk id="30" creationId="{4FE7625C-81EF-741E-88DB-49A258ADFB2E}"/>
          </ac:spMkLst>
        </pc:spChg>
        <pc:spChg chg="mod">
          <ac:chgData name="牧野 友幸" userId="3418e839-faa9-476d-b509-1fc4b11e6ea9" providerId="ADAL" clId="{0D8C08F9-12F7-469E-9D6D-956F12240F7D}" dt="2025-08-06T01:29:05.917" v="10" actId="552"/>
          <ac:spMkLst>
            <pc:docMk/>
            <pc:sldMk cId="2226767344" sldId="273"/>
            <ac:spMk id="33" creationId="{5C2D3C39-2807-5083-713B-CC180B602F16}"/>
          </ac:spMkLst>
        </pc:spChg>
        <pc:spChg chg="mod">
          <ac:chgData name="牧野 友幸" userId="3418e839-faa9-476d-b509-1fc4b11e6ea9" providerId="ADAL" clId="{0D8C08F9-12F7-469E-9D6D-956F12240F7D}" dt="2025-08-06T01:29:05.917" v="10" actId="552"/>
          <ac:spMkLst>
            <pc:docMk/>
            <pc:sldMk cId="2226767344" sldId="273"/>
            <ac:spMk id="34" creationId="{BCF88AA2-544B-5218-A819-D31083ADA62B}"/>
          </ac:spMkLst>
        </pc:spChg>
        <pc:spChg chg="mod">
          <ac:chgData name="牧野 友幸" userId="3418e839-faa9-476d-b509-1fc4b11e6ea9" providerId="ADAL" clId="{0D8C08F9-12F7-469E-9D6D-956F12240F7D}" dt="2025-08-06T01:29:05.917" v="10" actId="552"/>
          <ac:spMkLst>
            <pc:docMk/>
            <pc:sldMk cId="2226767344" sldId="273"/>
            <ac:spMk id="35" creationId="{6759AA33-3D76-D45F-DA74-B68987482D75}"/>
          </ac:spMkLst>
        </pc:spChg>
        <pc:spChg chg="mod">
          <ac:chgData name="牧野 友幸" userId="3418e839-faa9-476d-b509-1fc4b11e6ea9" providerId="ADAL" clId="{0D8C08F9-12F7-469E-9D6D-956F12240F7D}" dt="2025-08-06T01:29:01.542" v="9" actId="552"/>
          <ac:spMkLst>
            <pc:docMk/>
            <pc:sldMk cId="2226767344" sldId="273"/>
            <ac:spMk id="36" creationId="{59D9577A-F1B7-BFDD-4312-ADA8098B6EA3}"/>
          </ac:spMkLst>
        </pc:spChg>
        <pc:spChg chg="mod">
          <ac:chgData name="牧野 友幸" userId="3418e839-faa9-476d-b509-1fc4b11e6ea9" providerId="ADAL" clId="{0D8C08F9-12F7-469E-9D6D-956F12240F7D}" dt="2025-08-06T01:29:01.542" v="9" actId="552"/>
          <ac:spMkLst>
            <pc:docMk/>
            <pc:sldMk cId="2226767344" sldId="273"/>
            <ac:spMk id="37" creationId="{48E63313-A6C8-EA09-4ADD-310A2513A3E5}"/>
          </ac:spMkLst>
        </pc:spChg>
        <pc:spChg chg="mod">
          <ac:chgData name="牧野 友幸" userId="3418e839-faa9-476d-b509-1fc4b11e6ea9" providerId="ADAL" clId="{0D8C08F9-12F7-469E-9D6D-956F12240F7D}" dt="2025-08-06T01:29:01.542" v="9" actId="552"/>
          <ac:spMkLst>
            <pc:docMk/>
            <pc:sldMk cId="2226767344" sldId="273"/>
            <ac:spMk id="38" creationId="{734C1719-F666-14EC-D020-37C521230273}"/>
          </ac:spMkLst>
        </pc:spChg>
        <pc:graphicFrameChg chg="mod">
          <ac:chgData name="牧野 友幸" userId="3418e839-faa9-476d-b509-1fc4b11e6ea9" providerId="ADAL" clId="{0D8C08F9-12F7-469E-9D6D-956F12240F7D}" dt="2025-08-06T01:28:36.820" v="5" actId="1076"/>
          <ac:graphicFrameMkLst>
            <pc:docMk/>
            <pc:sldMk cId="2226767344" sldId="273"/>
            <ac:graphicFrameMk id="12" creationId="{4531FA6A-7660-A8B3-55F6-09448F568CA4}"/>
          </ac:graphicFrameMkLst>
        </pc:graphicFrameChg>
        <pc:graphicFrameChg chg="mod">
          <ac:chgData name="牧野 友幸" userId="3418e839-faa9-476d-b509-1fc4b11e6ea9" providerId="ADAL" clId="{0D8C08F9-12F7-469E-9D6D-956F12240F7D}" dt="2025-08-06T01:28:36.820" v="5" actId="1076"/>
          <ac:graphicFrameMkLst>
            <pc:docMk/>
            <pc:sldMk cId="2226767344" sldId="273"/>
            <ac:graphicFrameMk id="23" creationId="{307FC040-6DBA-F3F3-30C1-8C84C18168E2}"/>
          </ac:graphicFrameMkLst>
        </pc:graphicFrameChg>
      </pc:sldChg>
    </pc:docChg>
  </pc:docChgLst>
  <pc:docChgLst>
    <pc:chgData name="牧野 友幸" userId="3418e839-faa9-476d-b509-1fc4b11e6ea9" providerId="ADAL" clId="{FC649FD2-9046-48D2-A354-CF815E7BB768}"/>
    <pc:docChg chg="undo custSel modSld">
      <pc:chgData name="牧野 友幸" userId="3418e839-faa9-476d-b509-1fc4b11e6ea9" providerId="ADAL" clId="{FC649FD2-9046-48D2-A354-CF815E7BB768}" dt="2025-04-28T05:59:40.516" v="1452" actId="1035"/>
      <pc:docMkLst>
        <pc:docMk/>
      </pc:docMkLst>
      <pc:sldChg chg="addSp delSp modSp mod">
        <pc:chgData name="牧野 友幸" userId="3418e839-faa9-476d-b509-1fc4b11e6ea9" providerId="ADAL" clId="{FC649FD2-9046-48D2-A354-CF815E7BB768}" dt="2025-04-28T05:59:40.516" v="1452" actId="1035"/>
        <pc:sldMkLst>
          <pc:docMk/>
          <pc:sldMk cId="2226767344" sldId="27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527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380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13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15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571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3647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159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40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31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437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293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76D0FA-ED3A-4DC5-91CD-84FBE795C6FD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E6C50E-33F5-4E90-A614-3FAC2113048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683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オブジェクト 11">
            <a:extLst>
              <a:ext uri="{FF2B5EF4-FFF2-40B4-BE49-F238E27FC236}">
                <a16:creationId xmlns:a16="http://schemas.microsoft.com/office/drawing/2014/main" id="{4531FA6A-7660-A8B3-55F6-09448F568C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7148561"/>
              </p:ext>
            </p:extLst>
          </p:nvPr>
        </p:nvGraphicFramePr>
        <p:xfrm>
          <a:off x="1247298" y="1397653"/>
          <a:ext cx="2074863" cy="147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947087" imgH="2799117" progId="Prism6.Document">
                  <p:embed/>
                </p:oleObj>
              </mc:Choice>
              <mc:Fallback>
                <p:oleObj name="Prism 6" r:id="rId2" imgW="3947087" imgH="2799117" progId="Prism6.Document">
                  <p:embed/>
                  <p:pic>
                    <p:nvPicPr>
                      <p:cNvPr id="12" name="オブジェクト 11">
                        <a:extLst>
                          <a:ext uri="{FF2B5EF4-FFF2-40B4-BE49-F238E27FC236}">
                            <a16:creationId xmlns:a16="http://schemas.microsoft.com/office/drawing/2014/main" id="{4531FA6A-7660-A8B3-55F6-09448F568CA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47298" y="1397653"/>
                        <a:ext cx="2074863" cy="1471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BBE00E7D-D572-D813-6FA3-EFBC3FB876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6899645"/>
              </p:ext>
            </p:extLst>
          </p:nvPr>
        </p:nvGraphicFramePr>
        <p:xfrm>
          <a:off x="3971923" y="1397653"/>
          <a:ext cx="2076450" cy="147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3947087" imgH="2799117" progId="Prism6.Document">
                  <p:embed/>
                </p:oleObj>
              </mc:Choice>
              <mc:Fallback>
                <p:oleObj name="Prism 6" r:id="rId4" imgW="3947087" imgH="2799117" progId="Prism6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BBE00E7D-D572-D813-6FA3-EFBC3FB876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71923" y="1397653"/>
                        <a:ext cx="2076450" cy="1471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オブジェクト 13">
            <a:extLst>
              <a:ext uri="{FF2B5EF4-FFF2-40B4-BE49-F238E27FC236}">
                <a16:creationId xmlns:a16="http://schemas.microsoft.com/office/drawing/2014/main" id="{6B9B9BA3-682E-8894-5D94-06FA0A19BC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2158967"/>
              </p:ext>
            </p:extLst>
          </p:nvPr>
        </p:nvGraphicFramePr>
        <p:xfrm>
          <a:off x="1245711" y="5648940"/>
          <a:ext cx="2076450" cy="147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3947087" imgH="2799117" progId="Prism6.Document">
                  <p:embed/>
                </p:oleObj>
              </mc:Choice>
              <mc:Fallback>
                <p:oleObj name="Prism 6" r:id="rId6" imgW="3947087" imgH="2799117" progId="Prism6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6B9B9BA3-682E-8894-5D94-06FA0A19BC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245711" y="5648940"/>
                        <a:ext cx="2076450" cy="1471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オブジェクト 14">
            <a:extLst>
              <a:ext uri="{FF2B5EF4-FFF2-40B4-BE49-F238E27FC236}">
                <a16:creationId xmlns:a16="http://schemas.microsoft.com/office/drawing/2014/main" id="{3D5319AC-F979-0973-9897-1900F04A18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8789218"/>
              </p:ext>
            </p:extLst>
          </p:nvPr>
        </p:nvGraphicFramePr>
        <p:xfrm>
          <a:off x="1245711" y="3521728"/>
          <a:ext cx="2076450" cy="147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8" imgW="3947087" imgH="2799117" progId="Prism6.Document">
                  <p:embed/>
                </p:oleObj>
              </mc:Choice>
              <mc:Fallback>
                <p:oleObj name="Prism 6" r:id="rId8" imgW="3947087" imgH="2799117" progId="Prism6.Document">
                  <p:embed/>
                  <p:pic>
                    <p:nvPicPr>
                      <p:cNvPr id="15" name="オブジェクト 14">
                        <a:extLst>
                          <a:ext uri="{FF2B5EF4-FFF2-40B4-BE49-F238E27FC236}">
                            <a16:creationId xmlns:a16="http://schemas.microsoft.com/office/drawing/2014/main" id="{3D5319AC-F979-0973-9897-1900F04A18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45711" y="3521728"/>
                        <a:ext cx="2076450" cy="1471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オブジェクト 15">
            <a:extLst>
              <a:ext uri="{FF2B5EF4-FFF2-40B4-BE49-F238E27FC236}">
                <a16:creationId xmlns:a16="http://schemas.microsoft.com/office/drawing/2014/main" id="{4017E65F-4D69-F43A-D581-000866044F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7586077"/>
              </p:ext>
            </p:extLst>
          </p:nvPr>
        </p:nvGraphicFramePr>
        <p:xfrm>
          <a:off x="3971923" y="3521728"/>
          <a:ext cx="2076450" cy="147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3947087" imgH="2799117" progId="Prism6.Document">
                  <p:embed/>
                </p:oleObj>
              </mc:Choice>
              <mc:Fallback>
                <p:oleObj name="Prism 6" r:id="rId10" imgW="3947087" imgH="2799117" progId="Prism6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4017E65F-4D69-F43A-D581-000866044F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971923" y="3521728"/>
                        <a:ext cx="2076450" cy="1471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オブジェクト 16">
            <a:extLst>
              <a:ext uri="{FF2B5EF4-FFF2-40B4-BE49-F238E27FC236}">
                <a16:creationId xmlns:a16="http://schemas.microsoft.com/office/drawing/2014/main" id="{B6A9E0B9-0A9C-B1C7-FC18-15330C30C6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248957"/>
              </p:ext>
            </p:extLst>
          </p:nvPr>
        </p:nvGraphicFramePr>
        <p:xfrm>
          <a:off x="3971923" y="5648940"/>
          <a:ext cx="2076450" cy="147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2" imgW="3947087" imgH="2799117" progId="Prism6.Document">
                  <p:embed/>
                </p:oleObj>
              </mc:Choice>
              <mc:Fallback>
                <p:oleObj name="Prism 6" r:id="rId12" imgW="3947087" imgH="2799117" progId="Prism6.Document">
                  <p:embed/>
                  <p:pic>
                    <p:nvPicPr>
                      <p:cNvPr id="17" name="オブジェクト 16">
                        <a:extLst>
                          <a:ext uri="{FF2B5EF4-FFF2-40B4-BE49-F238E27FC236}">
                            <a16:creationId xmlns:a16="http://schemas.microsoft.com/office/drawing/2014/main" id="{B6A9E0B9-0A9C-B1C7-FC18-15330C30C6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971923" y="5648940"/>
                        <a:ext cx="2076450" cy="1471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29BEFBC5-7B26-E4AD-443B-5505AFA957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36416"/>
              </p:ext>
            </p:extLst>
          </p:nvPr>
        </p:nvGraphicFramePr>
        <p:xfrm>
          <a:off x="1245711" y="7776152"/>
          <a:ext cx="2076450" cy="147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4" imgW="3947087" imgH="2799117" progId="Prism6.Document">
                  <p:embed/>
                </p:oleObj>
              </mc:Choice>
              <mc:Fallback>
                <p:oleObj name="Prism 6" r:id="rId14" imgW="3947087" imgH="2799117" progId="Prism6.Document">
                  <p:embed/>
                  <p:pic>
                    <p:nvPicPr>
                      <p:cNvPr id="18" name="オブジェクト 17">
                        <a:extLst>
                          <a:ext uri="{FF2B5EF4-FFF2-40B4-BE49-F238E27FC236}">
                            <a16:creationId xmlns:a16="http://schemas.microsoft.com/office/drawing/2014/main" id="{29BEFBC5-7B26-E4AD-443B-5505AFA957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245711" y="7776152"/>
                        <a:ext cx="2076450" cy="147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75CDC85-E368-E6DB-CACA-69C3775F4F05}"/>
              </a:ext>
            </a:extLst>
          </p:cNvPr>
          <p:cNvSpPr txBox="1"/>
          <p:nvPr/>
        </p:nvSpPr>
        <p:spPr>
          <a:xfrm>
            <a:off x="434867" y="335209"/>
            <a:ext cx="598826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Figure S1. Recurrence-free survival after HDR-BT stratified by (a) age, (b) initial PSA, (c) clinical T stage, (d) clinical N stage, (e) Grade Group (GG), (f) pre HDR-BT PSA, and (g) HDR-BT protocol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B6AC1B4-33BB-2E36-7247-8485AF499DE6}"/>
              </a:ext>
            </a:extLst>
          </p:cNvPr>
          <p:cNvSpPr txBox="1"/>
          <p:nvPr/>
        </p:nvSpPr>
        <p:spPr>
          <a:xfrm>
            <a:off x="879580" y="1157738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350" b="1" dirty="0"/>
              <a:t>a</a:t>
            </a:r>
            <a:endParaRPr kumimoji="1" lang="ja-JP" altLang="en-US" sz="1350" b="1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97048F3B-72FC-80CB-00FE-E1F70C0315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8462415"/>
              </p:ext>
            </p:extLst>
          </p:nvPr>
        </p:nvGraphicFramePr>
        <p:xfrm>
          <a:off x="1095580" y="2896713"/>
          <a:ext cx="2160000" cy="216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e&lt;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7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8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Age</a:t>
                      </a:r>
                      <a:r>
                        <a:rPr lang="ja-JP" alt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≥</a:t>
                      </a: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4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4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4799714-45D6-6AF1-F4CD-356172619C31}"/>
              </a:ext>
            </a:extLst>
          </p:cNvPr>
          <p:cNvSpPr txBox="1"/>
          <p:nvPr/>
        </p:nvSpPr>
        <p:spPr>
          <a:xfrm>
            <a:off x="1095580" y="2711733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7D9ADE7A-5349-A961-2568-19D5AAA7F4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2927907"/>
              </p:ext>
            </p:extLst>
          </p:nvPr>
        </p:nvGraphicFramePr>
        <p:xfrm>
          <a:off x="3782420" y="2896713"/>
          <a:ext cx="2196000" cy="324000"/>
        </p:xfrm>
        <a:graphic>
          <a:graphicData uri="http://schemas.openxmlformats.org/drawingml/2006/table">
            <a:tbl>
              <a:tblPr/>
              <a:tblGrid>
                <a:gridCol w="396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SA</a:t>
                      </a:r>
                      <a:r>
                        <a:rPr lang="ja-JP" alt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1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9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20&lt;PSA</a:t>
                      </a:r>
                      <a:r>
                        <a:rPr lang="ja-JP" alt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6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40&lt;PS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17500039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9AA248-65E3-6DC4-089A-8B310A4C72A1}"/>
              </a:ext>
            </a:extLst>
          </p:cNvPr>
          <p:cNvSpPr txBox="1"/>
          <p:nvPr/>
        </p:nvSpPr>
        <p:spPr>
          <a:xfrm>
            <a:off x="3782420" y="2711733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graphicFrame>
        <p:nvGraphicFramePr>
          <p:cNvPr id="19" name="表 18">
            <a:extLst>
              <a:ext uri="{FF2B5EF4-FFF2-40B4-BE49-F238E27FC236}">
                <a16:creationId xmlns:a16="http://schemas.microsoft.com/office/drawing/2014/main" id="{869BEF50-9A5E-BB7F-B6CD-21F8811B56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0627922"/>
              </p:ext>
            </p:extLst>
          </p:nvPr>
        </p:nvGraphicFramePr>
        <p:xfrm>
          <a:off x="1095580" y="5017578"/>
          <a:ext cx="2160000" cy="216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&lt;cT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8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8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8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≥</a:t>
                      </a: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T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4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</a:tbl>
          </a:graphicData>
        </a:graphic>
      </p:graphicFrame>
      <p:graphicFrame>
        <p:nvGraphicFramePr>
          <p:cNvPr id="21" name="表 20">
            <a:extLst>
              <a:ext uri="{FF2B5EF4-FFF2-40B4-BE49-F238E27FC236}">
                <a16:creationId xmlns:a16="http://schemas.microsoft.com/office/drawing/2014/main" id="{E9C90FF7-10FB-1207-EC50-D253701AF8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5993077"/>
              </p:ext>
            </p:extLst>
          </p:nvPr>
        </p:nvGraphicFramePr>
        <p:xfrm>
          <a:off x="3818420" y="5017578"/>
          <a:ext cx="2160000" cy="216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N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cN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</a:tbl>
          </a:graphicData>
        </a:graphic>
      </p:graphicFrame>
      <p:graphicFrame>
        <p:nvGraphicFramePr>
          <p:cNvPr id="23" name="表 22">
            <a:extLst>
              <a:ext uri="{FF2B5EF4-FFF2-40B4-BE49-F238E27FC236}">
                <a16:creationId xmlns:a16="http://schemas.microsoft.com/office/drawing/2014/main" id="{307FC040-6DBA-F3F3-30C1-8C84C18168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5438382"/>
              </p:ext>
            </p:extLst>
          </p:nvPr>
        </p:nvGraphicFramePr>
        <p:xfrm>
          <a:off x="1095580" y="7144559"/>
          <a:ext cx="2160000" cy="324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 </a:t>
                      </a:r>
                      <a:r>
                        <a:rPr lang="ja-JP" alt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5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6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 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0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9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GG 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8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17500039"/>
                  </a:ext>
                </a:extLst>
              </a:tr>
            </a:tbl>
          </a:graphicData>
        </a:graphic>
      </p:graphicFrame>
      <p:graphicFrame>
        <p:nvGraphicFramePr>
          <p:cNvPr id="24" name="表 23">
            <a:extLst>
              <a:ext uri="{FF2B5EF4-FFF2-40B4-BE49-F238E27FC236}">
                <a16:creationId xmlns:a16="http://schemas.microsoft.com/office/drawing/2014/main" id="{A5785BA8-5A4B-31F5-A5CE-838A7DD67A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4107427"/>
              </p:ext>
            </p:extLst>
          </p:nvPr>
        </p:nvGraphicFramePr>
        <p:xfrm>
          <a:off x="3746420" y="7144559"/>
          <a:ext cx="2232000" cy="365760"/>
        </p:xfrm>
        <a:graphic>
          <a:graphicData uri="http://schemas.openxmlformats.org/drawingml/2006/table">
            <a:tbl>
              <a:tblPr/>
              <a:tblGrid>
                <a:gridCol w="432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e HDR-BT PSA </a:t>
                      </a:r>
                      <a:r>
                        <a:rPr lang="ja-JP" alt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≤</a:t>
                      </a: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7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7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Pre HDR-BT PSA &gt;0.0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4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5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</a:tbl>
          </a:graphicData>
        </a:graphic>
      </p:graphicFrame>
      <p:graphicFrame>
        <p:nvGraphicFramePr>
          <p:cNvPr id="25" name="表 24">
            <a:extLst>
              <a:ext uri="{FF2B5EF4-FFF2-40B4-BE49-F238E27FC236}">
                <a16:creationId xmlns:a16="http://schemas.microsoft.com/office/drawing/2014/main" id="{BD05E3DA-65AB-1C1C-4816-2570EFA070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8975627"/>
              </p:ext>
            </p:extLst>
          </p:nvPr>
        </p:nvGraphicFramePr>
        <p:xfrm>
          <a:off x="1095580" y="9269911"/>
          <a:ext cx="2160000" cy="216000"/>
        </p:xfrm>
        <a:graphic>
          <a:graphicData uri="http://schemas.openxmlformats.org/drawingml/2006/table">
            <a:tbl>
              <a:tblPr/>
              <a:tblGrid>
                <a:gridCol w="360000">
                  <a:extLst>
                    <a:ext uri="{9D8B030D-6E8A-4147-A177-3AD203B41FA5}">
                      <a16:colId xmlns:a16="http://schemas.microsoft.com/office/drawing/2014/main" val="35775811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15717482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19201586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1831567387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733060260"/>
                    </a:ext>
                  </a:extLst>
                </a:gridCol>
                <a:gridCol w="360000">
                  <a:extLst>
                    <a:ext uri="{9D8B030D-6E8A-4147-A177-3AD203B41FA5}">
                      <a16:colId xmlns:a16="http://schemas.microsoft.com/office/drawing/2014/main" val="264187818"/>
                    </a:ext>
                  </a:extLst>
                </a:gridCol>
              </a:tblGrid>
              <a:tr h="10800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9.5 Gy×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0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0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2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239883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  <a:cs typeface="Arial" panose="020B0604020202020204" pitchFamily="34" charset="0"/>
                        </a:rPr>
                        <a:t>13 Gy×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3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1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5872859"/>
                  </a:ext>
                </a:extLst>
              </a:tr>
            </a:tbl>
          </a:graphicData>
        </a:graphic>
      </p:graphicFrame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6A23C48-EDB0-DE03-9C8B-9F5966B912E6}"/>
              </a:ext>
            </a:extLst>
          </p:cNvPr>
          <p:cNvSpPr txBox="1"/>
          <p:nvPr/>
        </p:nvSpPr>
        <p:spPr>
          <a:xfrm>
            <a:off x="1095580" y="4832956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4EA92E8-3036-4343-C2CA-3222CB112754}"/>
              </a:ext>
            </a:extLst>
          </p:cNvPr>
          <p:cNvSpPr txBox="1"/>
          <p:nvPr/>
        </p:nvSpPr>
        <p:spPr>
          <a:xfrm>
            <a:off x="1095580" y="6961630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7062A59-303E-EEF4-C02A-1539C4384E72}"/>
              </a:ext>
            </a:extLst>
          </p:cNvPr>
          <p:cNvSpPr txBox="1"/>
          <p:nvPr/>
        </p:nvSpPr>
        <p:spPr>
          <a:xfrm>
            <a:off x="1095580" y="9090162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078217E-5176-2D88-82DA-9FE03F235583}"/>
              </a:ext>
            </a:extLst>
          </p:cNvPr>
          <p:cNvSpPr txBox="1"/>
          <p:nvPr/>
        </p:nvSpPr>
        <p:spPr>
          <a:xfrm>
            <a:off x="3782420" y="4832956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FE7625C-81EF-741E-88DB-49A258ADFB2E}"/>
              </a:ext>
            </a:extLst>
          </p:cNvPr>
          <p:cNvSpPr txBox="1"/>
          <p:nvPr/>
        </p:nvSpPr>
        <p:spPr>
          <a:xfrm>
            <a:off x="3782420" y="6961630"/>
            <a:ext cx="540000" cy="180000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r>
              <a:rPr lang="en-US" altLang="ja-JP" sz="600" dirty="0">
                <a:latin typeface="Palatino Linotype" panose="02040502050505030304" pitchFamily="18" charset="0"/>
                <a:cs typeface="Arial" panose="020B0604020202020204" pitchFamily="34" charset="0"/>
              </a:rPr>
              <a:t>No. at risk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C2D3C39-2807-5083-713B-CC180B602F16}"/>
              </a:ext>
            </a:extLst>
          </p:cNvPr>
          <p:cNvSpPr txBox="1"/>
          <p:nvPr/>
        </p:nvSpPr>
        <p:spPr>
          <a:xfrm>
            <a:off x="3566420" y="1157738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350" b="1" dirty="0"/>
              <a:t>b</a:t>
            </a:r>
            <a:endParaRPr kumimoji="1" lang="ja-JP" altLang="en-US" sz="1350" b="1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CF88AA2-544B-5218-A819-D31083ADA62B}"/>
              </a:ext>
            </a:extLst>
          </p:cNvPr>
          <p:cNvSpPr txBox="1"/>
          <p:nvPr/>
        </p:nvSpPr>
        <p:spPr>
          <a:xfrm>
            <a:off x="3566420" y="3317744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b="1" dirty="0"/>
              <a:t>d</a:t>
            </a:r>
            <a:endParaRPr kumimoji="1" lang="ja-JP" altLang="en-US" sz="1350" b="1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759AA33-3D76-D45F-DA74-B68987482D75}"/>
              </a:ext>
            </a:extLst>
          </p:cNvPr>
          <p:cNvSpPr txBox="1"/>
          <p:nvPr/>
        </p:nvSpPr>
        <p:spPr>
          <a:xfrm>
            <a:off x="3566420" y="5416459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b="1" dirty="0"/>
              <a:t>f</a:t>
            </a:r>
            <a:endParaRPr kumimoji="1" lang="ja-JP" altLang="en-US" sz="1350" b="1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9D9577A-F1B7-BFDD-4312-ADA8098B6EA3}"/>
              </a:ext>
            </a:extLst>
          </p:cNvPr>
          <p:cNvSpPr txBox="1"/>
          <p:nvPr/>
        </p:nvSpPr>
        <p:spPr>
          <a:xfrm>
            <a:off x="879580" y="3317744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b="1" dirty="0"/>
              <a:t>c</a:t>
            </a:r>
            <a:endParaRPr kumimoji="1" lang="ja-JP" altLang="en-US" sz="1350" b="1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8E63313-A6C8-EA09-4ADD-310A2513A3E5}"/>
              </a:ext>
            </a:extLst>
          </p:cNvPr>
          <p:cNvSpPr txBox="1"/>
          <p:nvPr/>
        </p:nvSpPr>
        <p:spPr>
          <a:xfrm>
            <a:off x="879580" y="5416459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b="1" dirty="0"/>
              <a:t>e</a:t>
            </a:r>
            <a:endParaRPr kumimoji="1" lang="ja-JP" altLang="en-US" sz="1350" b="1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34C1719-F666-14EC-D020-37C521230273}"/>
              </a:ext>
            </a:extLst>
          </p:cNvPr>
          <p:cNvSpPr txBox="1"/>
          <p:nvPr/>
        </p:nvSpPr>
        <p:spPr>
          <a:xfrm>
            <a:off x="879580" y="7526390"/>
            <a:ext cx="4320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350" b="1" dirty="0"/>
              <a:t>g</a:t>
            </a:r>
            <a:endParaRPr kumimoji="1" lang="ja-JP" altLang="en-US" sz="1350" b="1" dirty="0"/>
          </a:p>
        </p:txBody>
      </p:sp>
    </p:spTree>
    <p:extLst>
      <p:ext uri="{BB962C8B-B14F-4D97-AF65-F5344CB8AC3E}">
        <p14:creationId xmlns:p14="http://schemas.microsoft.com/office/powerpoint/2010/main" val="2226767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3</TotalTime>
  <Words>219</Words>
  <Application>Microsoft Office PowerPoint</Application>
  <PresentationFormat>A4 210 x 297 mm</PresentationFormat>
  <Paragraphs>11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 テーマ</vt:lpstr>
      <vt:lpstr>Prism 6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牧野 友幸</dc:creator>
  <cp:lastModifiedBy>牧野 友幸</cp:lastModifiedBy>
  <cp:revision>5</cp:revision>
  <dcterms:created xsi:type="dcterms:W3CDTF">2024-04-25T10:20:30Z</dcterms:created>
  <dcterms:modified xsi:type="dcterms:W3CDTF">2025-08-06T01:31:38Z</dcterms:modified>
</cp:coreProperties>
</file>